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34E812-E94E-4E9F-936E-C3AF2462396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B77A9A-299E-4549-BAB0-E6B8EDE76A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84A569-A0F0-43B6-A529-33B8400CC7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482196-5BD3-43C0-8CF2-9B6B8BCDC1C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C286D8-60F4-4DB5-97A7-FA74E23A83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1A5A8F-B56C-47B8-AF34-7AD413CF1D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421F8C-9E71-4784-A1DB-CEA86A8F20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EFBB83-5D59-4467-BBAA-6579F80A40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F0E507-34F4-46EC-AB1D-FD1EE84FBE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C6BC76-F833-4333-B143-31F8711A34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5EACE9-B96E-4CA8-B03D-1828DAF6B2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9EDDF1-B6FD-4DEE-9D4A-DCAEB21C0F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17B8E47-E267-4615-8E38-9FD8ACC43669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E:\HLY\Thesis\hly博士毕业论文\转录组抗旱机制发掘\Figs and tables\CP_FPKM_dotplot\CP1.jpeg"/>
          <p:cNvPicPr/>
          <p:nvPr/>
        </p:nvPicPr>
        <p:blipFill>
          <a:blip r:embed="rId1"/>
          <a:stretch/>
        </p:blipFill>
        <p:spPr>
          <a:xfrm>
            <a:off x="-7920" y="108000"/>
            <a:ext cx="2357280" cy="23572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E:\HLY\Thesis\hly博士毕业论文\转录组抗旱机制发掘\Figs and tables\CP_FPKM_dotplot\CP1D1.jpeg"/>
          <p:cNvPicPr/>
          <p:nvPr/>
        </p:nvPicPr>
        <p:blipFill>
          <a:blip r:embed="rId2"/>
          <a:stretch/>
        </p:blipFill>
        <p:spPr>
          <a:xfrm>
            <a:off x="2214720" y="108000"/>
            <a:ext cx="2357280" cy="23572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" descr="E:\HLY\Thesis\hly博士毕业论文\转录组抗旱机制发掘\Figs and tables\CP_FPKM_dotplot\CP1D2.jpeg"/>
          <p:cNvPicPr/>
          <p:nvPr/>
        </p:nvPicPr>
        <p:blipFill>
          <a:blip r:embed="rId3"/>
          <a:stretch/>
        </p:blipFill>
        <p:spPr>
          <a:xfrm>
            <a:off x="4508640" y="108000"/>
            <a:ext cx="2357280" cy="23572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5" descr="E:\HLY\Thesis\hly博士毕业论文\转录组抗旱机制发掘\Figs and tables\CP_FPKM_dotplot\CP3.jpeg"/>
          <p:cNvPicPr/>
          <p:nvPr/>
        </p:nvPicPr>
        <p:blipFill>
          <a:blip r:embed="rId4"/>
          <a:stretch/>
        </p:blipFill>
        <p:spPr>
          <a:xfrm>
            <a:off x="15840" y="264780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6" descr="E:\HLY\Thesis\hly博士毕业论文\转录组抗旱机制发掘\Figs and tables\CP_FPKM_dotplot\CP3D1.jpeg"/>
          <p:cNvPicPr/>
          <p:nvPr/>
        </p:nvPicPr>
        <p:blipFill>
          <a:blip r:embed="rId5"/>
          <a:stretch/>
        </p:blipFill>
        <p:spPr>
          <a:xfrm>
            <a:off x="2214720" y="2631960"/>
            <a:ext cx="2301840" cy="230184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7" descr="E:\HLY\Thesis\hly博士毕业论文\转录组抗旱机制发掘\Figs and tables\CP_FPKM_dotplot\CP3D2.jpeg"/>
          <p:cNvPicPr/>
          <p:nvPr/>
        </p:nvPicPr>
        <p:blipFill>
          <a:blip r:embed="rId6"/>
          <a:stretch/>
        </p:blipFill>
        <p:spPr>
          <a:xfrm>
            <a:off x="4572000" y="264780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8" descr="E:\HLY\Thesis\hly博士毕业论文\转录组抗旱机制发掘\Figs and tables\CP_FPKM_dotplot\CP16.jpeg"/>
          <p:cNvPicPr/>
          <p:nvPr/>
        </p:nvPicPr>
        <p:blipFill>
          <a:blip r:embed="rId7"/>
          <a:stretch/>
        </p:blipFill>
        <p:spPr>
          <a:xfrm>
            <a:off x="0" y="514836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9" descr="E:\HLY\Thesis\hly博士毕业论文\转录组抗旱机制发掘\Figs and tables\CP_FPKM_dotplot\CP16D1.jpeg"/>
          <p:cNvPicPr/>
          <p:nvPr/>
        </p:nvPicPr>
        <p:blipFill>
          <a:blip r:embed="rId8"/>
          <a:stretch/>
        </p:blipFill>
        <p:spPr>
          <a:xfrm>
            <a:off x="2214720" y="5132520"/>
            <a:ext cx="2301840" cy="230184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10" descr="E:\HLY\Thesis\hly博士毕业论文\转录组抗旱机制发掘\Figs and tables\CP_FPKM_dotplot\CP16D2.jpeg"/>
          <p:cNvPicPr/>
          <p:nvPr/>
        </p:nvPicPr>
        <p:blipFill>
          <a:blip r:embed="rId9"/>
          <a:stretch/>
        </p:blipFill>
        <p:spPr>
          <a:xfrm>
            <a:off x="4572000" y="5148360"/>
            <a:ext cx="2286000" cy="2286000"/>
          </a:xfrm>
          <a:prstGeom prst="rect">
            <a:avLst/>
          </a:prstGeom>
          <a:ln w="0">
            <a:noFill/>
          </a:ln>
        </p:spPr>
      </p:pic>
      <p:sp>
        <p:nvSpPr>
          <p:cNvPr id="50" name="TextBox 10"/>
          <p:cNvSpPr/>
          <p:nvPr/>
        </p:nvSpPr>
        <p:spPr>
          <a:xfrm>
            <a:off x="714240" y="2322360"/>
            <a:ext cx="1500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HZ-c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1"/>
          <p:cNvSpPr/>
          <p:nvPr/>
        </p:nvSpPr>
        <p:spPr>
          <a:xfrm>
            <a:off x="2928960" y="2309760"/>
            <a:ext cx="150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HZ-1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2"/>
          <p:cNvSpPr/>
          <p:nvPr/>
        </p:nvSpPr>
        <p:spPr>
          <a:xfrm>
            <a:off x="5357880" y="2322360"/>
            <a:ext cx="150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HZ-3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3"/>
          <p:cNvSpPr/>
          <p:nvPr/>
        </p:nvSpPr>
        <p:spPr>
          <a:xfrm>
            <a:off x="785880" y="4803840"/>
            <a:ext cx="150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28-c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4"/>
          <p:cNvSpPr/>
          <p:nvPr/>
        </p:nvSpPr>
        <p:spPr>
          <a:xfrm>
            <a:off x="3000240" y="4791240"/>
            <a:ext cx="1500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28-1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5"/>
          <p:cNvSpPr/>
          <p:nvPr/>
        </p:nvSpPr>
        <p:spPr>
          <a:xfrm>
            <a:off x="5357880" y="4803840"/>
            <a:ext cx="150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28-3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6"/>
          <p:cNvSpPr/>
          <p:nvPr/>
        </p:nvSpPr>
        <p:spPr>
          <a:xfrm>
            <a:off x="714240" y="7291440"/>
            <a:ext cx="1500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471-c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7"/>
          <p:cNvSpPr/>
          <p:nvPr/>
        </p:nvSpPr>
        <p:spPr>
          <a:xfrm>
            <a:off x="2928960" y="7291440"/>
            <a:ext cx="150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471-1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8"/>
          <p:cNvSpPr/>
          <p:nvPr/>
        </p:nvSpPr>
        <p:spPr>
          <a:xfrm>
            <a:off x="5214960" y="7291440"/>
            <a:ext cx="150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471-3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1"/>
          <p:cNvSpPr/>
          <p:nvPr/>
        </p:nvSpPr>
        <p:spPr>
          <a:xfrm>
            <a:off x="260280" y="7885080"/>
            <a:ext cx="65977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2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elation analysis of Illumina sequencing results between two replicates of each sample for H471, P28, and HHZ under control (ck), 1d and 3d drought stress, respectively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2-02T13:46:23Z</dcterms:created>
  <dc:creator>516</dc:creator>
  <dc:description/>
  <dc:language>en-US</dc:language>
  <cp:lastModifiedBy>Lenovo User</cp:lastModifiedBy>
  <dcterms:modified xsi:type="dcterms:W3CDTF">2014-06-18T13:17:40Z</dcterms:modified>
  <cp:revision>8</cp:revision>
  <dc:subject/>
  <dc:title>幻灯片 1</dc:title>
</cp:coreProperties>
</file>